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CE43BD-40ED-45EC-9D54-462C309BEE03}" type="slidenum">
              <a:rPr b="0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Foliennummernplatzhalt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79B9FF-D277-46C4-B387-CBDD2CC8F525}" type="slidenum">
              <a:rPr b="0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231AE-74C8-4AE4-B408-28A9C5ED1D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71C14-5A33-4EB8-B738-0A7CA55EEC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0E5AF-5B4D-4509-B2D6-EA7E19077A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E26E5-F134-46B1-A188-D76B053D11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9F289-DBDD-424B-9ACC-682392B4FA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5C982-13D8-4B0C-95FA-8BF6125682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57DA53-1FE6-4A4A-84C1-EDCF856466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69F65-6F15-4BFD-915C-B8D11C897B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049CC-FA0C-4EEC-8645-72498F849D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C4A8D9-2F1D-4A3F-A313-0EC3E09222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D4D2DE-8D72-42F0-A826-233F328EDB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37507-D9E0-48AB-9D3F-4E57A461B3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ABEA04-F802-4181-A21E-88CA5F27E33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feld 7"/>
          <p:cNvSpPr/>
          <p:nvPr/>
        </p:nvSpPr>
        <p:spPr>
          <a:xfrm>
            <a:off x="2520" y="11160"/>
            <a:ext cx="84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1144440" y="33480"/>
            <a:ext cx="7008840" cy="5910120"/>
          </a:xfrm>
          <a:prstGeom prst="rect">
            <a:avLst/>
          </a:prstGeom>
          <a:ln w="0">
            <a:noFill/>
          </a:ln>
        </p:spPr>
      </p:pic>
      <p:sp>
        <p:nvSpPr>
          <p:cNvPr id="50" name="AutoShape 11"/>
          <p:cNvSpPr/>
          <p:nvPr/>
        </p:nvSpPr>
        <p:spPr>
          <a:xfrm>
            <a:off x="965160" y="304920"/>
            <a:ext cx="7008840" cy="59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AutoShape 10568"/>
          <p:cNvSpPr/>
          <p:nvPr/>
        </p:nvSpPr>
        <p:spPr>
          <a:xfrm>
            <a:off x="965160" y="304920"/>
            <a:ext cx="7008840" cy="59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AutoShape 21125"/>
          <p:cNvSpPr/>
          <p:nvPr/>
        </p:nvSpPr>
        <p:spPr>
          <a:xfrm>
            <a:off x="965160" y="304920"/>
            <a:ext cx="7008840" cy="591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feld 7"/>
          <p:cNvSpPr/>
          <p:nvPr/>
        </p:nvSpPr>
        <p:spPr>
          <a:xfrm>
            <a:off x="1143000" y="6059520"/>
            <a:ext cx="6948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ot Plots displaying Optimal MULTIMER Staining.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The four given donors (columns) were stained without (FMO), irrelevant, CMV-pp65 or MelanA Multimer. The seven detecable responses for CMV-pp65 and MelanA of all donors were marked with an asteris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feld 15"/>
          <p:cNvSpPr/>
          <p:nvPr/>
        </p:nvSpPr>
        <p:spPr>
          <a:xfrm>
            <a:off x="3050280" y="312408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1f497d"/>
                </a:solidFill>
                <a:latin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feld 16"/>
          <p:cNvSpPr/>
          <p:nvPr/>
        </p:nvSpPr>
        <p:spPr>
          <a:xfrm>
            <a:off x="6118920" y="314316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1f497d"/>
                </a:solidFill>
                <a:latin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feld 17"/>
          <p:cNvSpPr/>
          <p:nvPr/>
        </p:nvSpPr>
        <p:spPr>
          <a:xfrm>
            <a:off x="7698240" y="314316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1f497d"/>
                </a:solidFill>
                <a:latin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feld 18"/>
          <p:cNvSpPr/>
          <p:nvPr/>
        </p:nvSpPr>
        <p:spPr>
          <a:xfrm>
            <a:off x="7698240" y="459108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1f497d"/>
                </a:solidFill>
                <a:latin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feld 19"/>
          <p:cNvSpPr/>
          <p:nvPr/>
        </p:nvSpPr>
        <p:spPr>
          <a:xfrm>
            <a:off x="6118920" y="457200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1f497d"/>
                </a:solidFill>
                <a:latin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feld 20"/>
          <p:cNvSpPr/>
          <p:nvPr/>
        </p:nvSpPr>
        <p:spPr>
          <a:xfrm>
            <a:off x="4574160" y="457200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1f497d"/>
                </a:solidFill>
                <a:latin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feld 21"/>
          <p:cNvSpPr/>
          <p:nvPr/>
        </p:nvSpPr>
        <p:spPr>
          <a:xfrm>
            <a:off x="3050280" y="4591080"/>
            <a:ext cx="279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000" spc="-1" strike="noStrike">
                <a:solidFill>
                  <a:srgbClr val="1f497d"/>
                </a:solidFill>
                <a:latin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feld 7"/>
          <p:cNvSpPr/>
          <p:nvPr/>
        </p:nvSpPr>
        <p:spPr>
          <a:xfrm>
            <a:off x="-6120" y="11160"/>
            <a:ext cx="79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2" name=""/>
          <p:cNvGraphicFramePr/>
          <p:nvPr/>
        </p:nvGraphicFramePr>
        <p:xfrm>
          <a:off x="331920" y="457200"/>
          <a:ext cx="8348400" cy="4898880"/>
        </p:xfrm>
        <a:graphic>
          <a:graphicData uri="http://schemas.openxmlformats.org/drawingml/2006/table">
            <a:tbl>
              <a:tblPr/>
              <a:tblGrid>
                <a:gridCol w="850680"/>
                <a:gridCol w="638280"/>
                <a:gridCol w="852480"/>
                <a:gridCol w="979560"/>
                <a:gridCol w="1096920"/>
                <a:gridCol w="982800"/>
                <a:gridCol w="982440"/>
                <a:gridCol w="982800"/>
                <a:gridCol w="982440"/>
              </a:tblGrid>
              <a:tr h="2134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cc00"/>
                          </a:solidFill>
                          <a:latin typeface="Arial"/>
                          <a:ea typeface="Times New Roman"/>
                        </a:rPr>
                        <a:t>Lab Reported Response = Y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Lab Reported Response = N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60804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ntige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ono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ump Channe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ntral Eval Score=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ntral Eval Score=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ntral Eval Score=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ntral Eval Score=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ntral Eval Score=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ntral Eval Score=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M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p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64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64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0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ot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cc00"/>
                          </a:solidFill>
                          <a:latin typeface="Arial"/>
                          <a:ea typeface="Times New Roman"/>
                        </a:rPr>
                        <a:t>19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cc00"/>
                          </a:solidFill>
                          <a:latin typeface="Arial"/>
                          <a:ea typeface="Times New Roman"/>
                        </a:rPr>
                        <a:t>6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2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</a:tr>
              <a:tr h="260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ffff">
                        <a:alpha val="80000"/>
                      </a:srgbClr>
                    </a:solidFill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ela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64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772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64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628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1640"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ot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bfbfb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bfbfb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bfbfb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1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bfbfb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bfbfb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cc00"/>
                          </a:solidFill>
                          <a:latin typeface="Arial"/>
                          <a:ea typeface="Times New Roman"/>
                        </a:rPr>
                        <a:t>12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bfbfb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cc00"/>
                          </a:solidFill>
                          <a:latin typeface="Arial"/>
                          <a:ea typeface="Times New Roman"/>
                        </a:rPr>
                        <a:t>6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bfbfb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bfbfbf">
                        <a:alpha val="80000"/>
                      </a:srgbClr>
                    </a:solidFill>
                  </a:tcPr>
                </a:tc>
                <a:tc>
                  <a:txBody>
                    <a:bodyPr lIns="55080" rIns="5508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0000"/>
                          </a:solidFill>
                          <a:latin typeface="Arial"/>
                          <a:ea typeface="Times New Roman"/>
                        </a:rPr>
                        <a:t>2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5080" marR="5508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bfbfbf">
                        <a:alpha val="80000"/>
                      </a:srgbClr>
                    </a:solidFill>
                  </a:tcPr>
                </a:tc>
              </a:tr>
            </a:tbl>
          </a:graphicData>
        </a:graphic>
      </p:graphicFrame>
      <p:sp>
        <p:nvSpPr>
          <p:cNvPr id="63" name="Textfeld 7"/>
          <p:cNvSpPr/>
          <p:nvPr/>
        </p:nvSpPr>
        <p:spPr>
          <a:xfrm>
            <a:off x="304920" y="5562720"/>
            <a:ext cx="838188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mparison of results: Central Evaluation vs. Lab Evaluation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or the CMV stainings (upper part), there were 263 stainings (194 ‘YES’ + 69 ‘NO’) where the lab reported response came to the same conclusion as the central optical evaluation. Hence there was 83% agreement. There were 35 stainings (11 ‘YES’ + 24 ‘NO’) where the self reported response came to a different conclusion from the CVC central optical evaluation. Hence there was 11% disagreement. For the Melan A stainings (lower part) there was only 60% agreement (n=190: 128 ‘YES’ + 62 ‘NO’) and 12% disagreement (n=39: 19 ‘YES’ + 20 ‘NO’).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feld 7"/>
          <p:cNvSpPr/>
          <p:nvPr/>
        </p:nvSpPr>
        <p:spPr>
          <a:xfrm>
            <a:off x="-6120" y="11160"/>
            <a:ext cx="79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Tabl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5" name=""/>
          <p:cNvGraphicFramePr/>
          <p:nvPr/>
        </p:nvGraphicFramePr>
        <p:xfrm>
          <a:off x="884160" y="1219320"/>
          <a:ext cx="7421760" cy="3348000"/>
        </p:xfrm>
        <a:graphic>
          <a:graphicData uri="http://schemas.openxmlformats.org/drawingml/2006/table">
            <a:tbl>
              <a:tblPr/>
              <a:tblGrid>
                <a:gridCol w="1365480"/>
                <a:gridCol w="1733400"/>
                <a:gridCol w="1473120"/>
                <a:gridCol w="1495440"/>
                <a:gridCol w="1354320"/>
              </a:tblGrid>
              <a:tr h="6699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Variabl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umber of Replica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umber of Respons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% of Respons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umber of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lt;100,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9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0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D8-positiv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0,000-150,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2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372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ll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gt;150,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0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umber of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6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lor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6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Us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9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2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480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9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6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6" name="Textfeld 7"/>
          <p:cNvSpPr/>
          <p:nvPr/>
        </p:nvSpPr>
        <p:spPr>
          <a:xfrm>
            <a:off x="838080" y="4687920"/>
            <a:ext cx="7452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uplicates within Subgroup and Responses Detected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ree subgroups were generated by the analysed number of analysed CD8-positive cells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(upper part) and the number of used colors (lower part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er replicate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. For each subgroup the number of replicates and detected responses are listed and the percentage of positive responses is given in the tabl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C Britten</dc:creator>
  <dc:description/>
  <dc:language>en-US</dc:language>
  <cp:lastModifiedBy>C Britten</cp:lastModifiedBy>
  <dcterms:modified xsi:type="dcterms:W3CDTF">2011-07-01T14:57:33Z</dcterms:modified>
  <cp:revision>70</cp:revision>
  <dc:subject/>
  <dc:title>Folie 1</dc:title>
</cp:coreProperties>
</file>